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8" r:id="rId2"/>
    <p:sldId id="259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265C726-3DE5-49A8-A8AB-01B05B2F786D}" v="20" dt="2025-04-23T20:05:13.5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51963" autoAdjust="0"/>
  </p:normalViewPr>
  <p:slideViewPr>
    <p:cSldViewPr snapToGrid="0">
      <p:cViewPr varScale="1">
        <p:scale>
          <a:sx n="22" d="100"/>
          <a:sy n="22" d="100"/>
        </p:scale>
        <p:origin x="3221" y="5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雄康 大野" userId="289040ba27705a35" providerId="LiveId" clId="{9265C726-3DE5-49A8-A8AB-01B05B2F786D}"/>
    <pc:docChg chg="undo custSel delSld modSld">
      <pc:chgData name="雄康 大野" userId="289040ba27705a35" providerId="LiveId" clId="{9265C726-3DE5-49A8-A8AB-01B05B2F786D}" dt="2025-05-02T08:58:57.273" v="750"/>
      <pc:docMkLst>
        <pc:docMk/>
      </pc:docMkLst>
      <pc:sldChg chg="del">
        <pc:chgData name="雄康 大野" userId="289040ba27705a35" providerId="LiveId" clId="{9265C726-3DE5-49A8-A8AB-01B05B2F786D}" dt="2025-04-23T19:26:37.948" v="0" actId="47"/>
        <pc:sldMkLst>
          <pc:docMk/>
          <pc:sldMk cId="3080828672" sldId="256"/>
        </pc:sldMkLst>
      </pc:sldChg>
      <pc:sldChg chg="del">
        <pc:chgData name="雄康 大野" userId="289040ba27705a35" providerId="LiveId" clId="{9265C726-3DE5-49A8-A8AB-01B05B2F786D}" dt="2025-04-23T19:26:40.591" v="1" actId="47"/>
        <pc:sldMkLst>
          <pc:docMk/>
          <pc:sldMk cId="1345114765" sldId="257"/>
        </pc:sldMkLst>
      </pc:sldChg>
      <pc:sldChg chg="addSp delSp modSp mod modNotesTx">
        <pc:chgData name="雄康 大野" userId="289040ba27705a35" providerId="LiveId" clId="{9265C726-3DE5-49A8-A8AB-01B05B2F786D}" dt="2025-05-02T08:58:47.579" v="749" actId="57"/>
        <pc:sldMkLst>
          <pc:docMk/>
          <pc:sldMk cId="3221259309" sldId="258"/>
        </pc:sldMkLst>
        <pc:spChg chg="mod">
          <ac:chgData name="雄康 大野" userId="289040ba27705a35" providerId="LiveId" clId="{9265C726-3DE5-49A8-A8AB-01B05B2F786D}" dt="2025-04-24T00:12:42.769" v="725" actId="1036"/>
          <ac:spMkLst>
            <pc:docMk/>
            <pc:sldMk cId="3221259309" sldId="258"/>
            <ac:spMk id="2" creationId="{7AE3A8E4-DABE-00CE-0F08-9B44F4D29482}"/>
          </ac:spMkLst>
        </pc:spChg>
        <pc:spChg chg="mod">
          <ac:chgData name="雄康 大野" userId="289040ba27705a35" providerId="LiveId" clId="{9265C726-3DE5-49A8-A8AB-01B05B2F786D}" dt="2025-04-23T19:39:59.868" v="497" actId="1035"/>
          <ac:spMkLst>
            <pc:docMk/>
            <pc:sldMk cId="3221259309" sldId="258"/>
            <ac:spMk id="6" creationId="{0747F03B-A5F9-C50D-7161-83B3E427942B}"/>
          </ac:spMkLst>
        </pc:spChg>
        <pc:spChg chg="mod">
          <ac:chgData name="雄康 大野" userId="289040ba27705a35" providerId="LiveId" clId="{9265C726-3DE5-49A8-A8AB-01B05B2F786D}" dt="2025-04-23T19:39:32.888" v="439" actId="1035"/>
          <ac:spMkLst>
            <pc:docMk/>
            <pc:sldMk cId="3221259309" sldId="258"/>
            <ac:spMk id="10" creationId="{71708E19-81B2-B263-2794-FABF7848F899}"/>
          </ac:spMkLst>
        </pc:spChg>
        <pc:spChg chg="mod">
          <ac:chgData name="雄康 大野" userId="289040ba27705a35" providerId="LiveId" clId="{9265C726-3DE5-49A8-A8AB-01B05B2F786D}" dt="2025-04-23T19:38:47.086" v="201" actId="1036"/>
          <ac:spMkLst>
            <pc:docMk/>
            <pc:sldMk cId="3221259309" sldId="258"/>
            <ac:spMk id="11" creationId="{6A738D1E-C8BE-FA78-535A-BDB87DE7FA40}"/>
          </ac:spMkLst>
        </pc:spChg>
        <pc:spChg chg="add mod">
          <ac:chgData name="雄康 大野" userId="289040ba27705a35" providerId="LiveId" clId="{9265C726-3DE5-49A8-A8AB-01B05B2F786D}" dt="2025-04-23T19:39:11.182" v="324" actId="1035"/>
          <ac:spMkLst>
            <pc:docMk/>
            <pc:sldMk cId="3221259309" sldId="258"/>
            <ac:spMk id="14" creationId="{496AD7E2-F312-BC22-38F7-6D90EAE18DF0}"/>
          </ac:spMkLst>
        </pc:spChg>
        <pc:graphicFrameChg chg="mod modGraphic">
          <ac:chgData name="雄康 大野" userId="289040ba27705a35" providerId="LiveId" clId="{9265C726-3DE5-49A8-A8AB-01B05B2F786D}" dt="2025-04-23T20:05:13.570" v="657"/>
          <ac:graphicFrameMkLst>
            <pc:docMk/>
            <pc:sldMk cId="3221259309" sldId="258"/>
            <ac:graphicFrameMk id="3" creationId="{F9F1A32F-880C-705E-38B9-150DD3B2A6AB}"/>
          </ac:graphicFrameMkLst>
        </pc:graphicFrameChg>
        <pc:graphicFrameChg chg="add del mod ord">
          <ac:chgData name="雄康 大野" userId="289040ba27705a35" providerId="LiveId" clId="{9265C726-3DE5-49A8-A8AB-01B05B2F786D}" dt="2025-04-23T19:38:29.114" v="180" actId="1037"/>
          <ac:graphicFrameMkLst>
            <pc:docMk/>
            <pc:sldMk cId="3221259309" sldId="258"/>
            <ac:graphicFrameMk id="7" creationId="{229F4387-1F89-CC3B-420C-5E56E29448CF}"/>
          </ac:graphicFrameMkLst>
        </pc:graphicFrameChg>
      </pc:sldChg>
      <pc:sldChg chg="addSp delSp modSp mod modNotesTx">
        <pc:chgData name="雄康 大野" userId="289040ba27705a35" providerId="LiveId" clId="{9265C726-3DE5-49A8-A8AB-01B05B2F786D}" dt="2025-05-02T08:58:57.273" v="750"/>
        <pc:sldMkLst>
          <pc:docMk/>
          <pc:sldMk cId="2534779906" sldId="259"/>
        </pc:sldMkLst>
        <pc:spChg chg="mod">
          <ac:chgData name="雄康 大野" userId="289040ba27705a35" providerId="LiveId" clId="{9265C726-3DE5-49A8-A8AB-01B05B2F786D}" dt="2025-04-23T20:00:16.369" v="646" actId="1037"/>
          <ac:spMkLst>
            <pc:docMk/>
            <pc:sldMk cId="2534779906" sldId="259"/>
            <ac:spMk id="8" creationId="{8AAC6AFC-2889-02FF-068D-B9A6CE5187B7}"/>
          </ac:spMkLst>
        </pc:spChg>
        <pc:spChg chg="mod">
          <ac:chgData name="雄康 大野" userId="289040ba27705a35" providerId="LiveId" clId="{9265C726-3DE5-49A8-A8AB-01B05B2F786D}" dt="2025-04-23T19:59:55.830" v="625" actId="1035"/>
          <ac:spMkLst>
            <pc:docMk/>
            <pc:sldMk cId="2534779906" sldId="259"/>
            <ac:spMk id="10" creationId="{BB3C92D1-00D6-E17F-FC9B-AAAD2C54ED1E}"/>
          </ac:spMkLst>
        </pc:spChg>
        <pc:spChg chg="mod">
          <ac:chgData name="雄康 大野" userId="289040ba27705a35" providerId="LiveId" clId="{9265C726-3DE5-49A8-A8AB-01B05B2F786D}" dt="2025-04-24T00:13:22.709" v="730" actId="1036"/>
          <ac:spMkLst>
            <pc:docMk/>
            <pc:sldMk cId="2534779906" sldId="259"/>
            <ac:spMk id="11" creationId="{3C010111-196B-4AEA-A145-F1BEE597F77B}"/>
          </ac:spMkLst>
        </pc:spChg>
        <pc:spChg chg="mod">
          <ac:chgData name="雄康 大野" userId="289040ba27705a35" providerId="LiveId" clId="{9265C726-3DE5-49A8-A8AB-01B05B2F786D}" dt="2025-04-23T19:59:39.769" v="603" actId="1035"/>
          <ac:spMkLst>
            <pc:docMk/>
            <pc:sldMk cId="2534779906" sldId="259"/>
            <ac:spMk id="12" creationId="{2D734124-D9A4-BC7C-5CAF-BD03029215D3}"/>
          </ac:spMkLst>
        </pc:spChg>
        <pc:graphicFrameChg chg="mod modGraphic">
          <ac:chgData name="雄康 大野" userId="289040ba27705a35" providerId="LiveId" clId="{9265C726-3DE5-49A8-A8AB-01B05B2F786D}" dt="2025-04-23T23:01:28.740" v="703" actId="20577"/>
          <ac:graphicFrameMkLst>
            <pc:docMk/>
            <pc:sldMk cId="2534779906" sldId="259"/>
            <ac:graphicFrameMk id="3" creationId="{94A5201F-C166-66D2-1A48-393FF02D5ECF}"/>
          </ac:graphicFrameMkLst>
        </pc:graphicFrameChg>
        <pc:graphicFrameChg chg="add mod ord">
          <ac:chgData name="雄康 大野" userId="289040ba27705a35" providerId="LiveId" clId="{9265C726-3DE5-49A8-A8AB-01B05B2F786D}" dt="2025-04-23T19:58:46.623" v="585" actId="167"/>
          <ac:graphicFrameMkLst>
            <pc:docMk/>
            <pc:sldMk cId="2534779906" sldId="259"/>
            <ac:graphicFrameMk id="15" creationId="{A6A9B90E-F9E4-E2FA-23D5-5357146C8390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65E09E-6405-46B4-8073-95D12C59FD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0A9EAD-5110-44BA-8A25-A267064F61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6141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F4C560-EF82-B40D-4156-46837AE9D1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C20CD46D-56ED-9D97-0ED3-20095F44BA6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A0C74E2-4658-52C1-584D-8E1F4106840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Figure. Odds ratios of severe trauma (ISS of &gt;15) and anatomical site-specific severe injury (AIS score of ≥3) for each body component among (A) male and (B) female subgroups</a:t>
            </a:r>
          </a:p>
          <a:p>
            <a:pPr algn="just">
              <a:lnSpc>
                <a:spcPct val="200000"/>
              </a:lnSpc>
              <a:buNone/>
            </a:pP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group is the driver seat occupants. An adjusted association of decreased risk of severe trauma (ISS of &gt;15) and severe chest injuries was observed regardless of sex differences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djuste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or age, sex, admission year, season, presentation time, presentation day, prehospital length of stay, vehicle configuration, collision type, seatbelt use, airbag deployment, and involvement in high-energy trauma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365); the c-statistic for the model was 0.795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361); the c-statistic for the model was 0.888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661); the c-statistic for the model was 0.84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478); the c-statistic for the model was 0.855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455); the c-statistic for the model was 0.838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p-value was &lt;0.001; the c-statistic for the model was 0.87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395); the c-statistic for the model was 0.818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763); the c-statistic for the model was 0.86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j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742); the c-statistic for the model was 0.85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785). AIS, Abbreviated Injury Scale; ISS, Injury Severity Score; OR, odds ratio; CI, confidence interval. *p &lt; 0.025.</a:t>
            </a: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76269D5-A593-970C-0516-D1740E8201E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0A9EAD-5110-44BA-8A25-A267064F61A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00651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EF0DF2-CDAC-18B5-8B6F-781F4DA2A1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F49382FD-9BA7-8114-A480-D258985034B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B08DE91F-9E12-6AEA-4FC5-0BCF738F25D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Figure. Odds ratios of severe trauma (ISS of &gt;15) and anatomical site-specific severe injury (AIS score of ≥3) for each body component among (A) male and (B) female subgroups</a:t>
            </a:r>
          </a:p>
          <a:p>
            <a:pPr algn="just">
              <a:lnSpc>
                <a:spcPct val="200000"/>
              </a:lnSpc>
              <a:buNone/>
            </a:pP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group is the driver seat occupants. An adjusted association of decreased risk of severe trauma (ISS of &gt;15) and severe chest injuries was observed regardless of sex differences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djuste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or age, sex, admission year, season, presentation time, presentation day, prehospital length of stay, vehicle configuration, collision type, seatbelt use, airbag deployment, and involvement in high-energy trauma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365); the c-statistic for the model was 0.795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361); the c-statistic for the model was 0.888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661); the c-statistic for the model was 0.84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478); the c-statistic for the model was 0.855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455); the c-statistic for the model was 0.838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p-value was &lt;0.001; the c-statistic for the model was 0.87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395); the c-statistic for the model was 0.818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763); the c-statistic for the model was 0.86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j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742); the c-statistic for the model was 0.851. </a:t>
            </a:r>
            <a:r>
              <a:rPr lang="en-US" altLang="ja-JP" sz="1800" b="0" kern="100" baseline="300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 (p = 0.785). AIS, Abbreviated Injury Scale; ISS, Injury Severity Score; OR, odds ratio; CI, confidence interval. </a:t>
            </a:r>
            <a:r>
              <a:rPr lang="en-US" altLang="ja-JP" sz="1800" b="0" kern="10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p &lt; 0.025.</a:t>
            </a:r>
            <a:endParaRPr lang="en-US" altLang="ja-JP" sz="1800" b="0" kern="100" dirty="0">
              <a:solidFill>
                <a:srgbClr val="FF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0BE7884-309D-47CD-6AAB-DDB05EF516D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0A9EAD-5110-44BA-8A25-A267064F61A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830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0400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1685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8865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606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553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571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6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8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138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195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9984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7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5211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7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206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6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282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438F45-BA58-C34C-8188-F0F8693BC0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229F4387-1F89-CC3B-420C-5E56E29448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220655"/>
              </p:ext>
            </p:extLst>
          </p:nvPr>
        </p:nvGraphicFramePr>
        <p:xfrm>
          <a:off x="2301421" y="811448"/>
          <a:ext cx="5451617" cy="121173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087735" imgH="2220243" progId="Prism9.Document">
                  <p:embed/>
                </p:oleObj>
              </mc:Choice>
              <mc:Fallback>
                <p:oleObj name="Prism 9" r:id="rId3" imgW="2087735" imgH="2220243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229F4387-1F89-CC3B-420C-5E56E29448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01421" y="811448"/>
                        <a:ext cx="5451617" cy="121173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F9F1A32F-880C-705E-38B9-150DD3B2A6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0725814"/>
              </p:ext>
            </p:extLst>
          </p:nvPr>
        </p:nvGraphicFramePr>
        <p:xfrm>
          <a:off x="359988" y="695609"/>
          <a:ext cx="2804160" cy="1004443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52855">
                  <a:extLst>
                    <a:ext uri="{9D8B030D-6E8A-4147-A177-3AD203B41FA5}">
                      <a16:colId xmlns:a16="http://schemas.microsoft.com/office/drawing/2014/main" val="2425432630"/>
                    </a:ext>
                  </a:extLst>
                </a:gridCol>
                <a:gridCol w="1551305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276625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</a:t>
                      </a:r>
                      <a:r>
                        <a:rPr kumimoji="1" lang="ja-JP" alt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(95% CI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0908"/>
                  </a:ext>
                </a:extLst>
              </a:tr>
              <a:tr h="276625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vere trauma with ISS of &gt;15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1383435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,37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2811529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4525445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3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55 (0.469-0.914)*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62 (0.447-0.980)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813 (0.591-1.119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10 (0.263-0.640)*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  <a:tr h="276625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head or neck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8245664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,37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238151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8458124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3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3 (0.580-1.255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7200001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3 (0.515-1.220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1277607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0 (0.898-1.795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2159094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0 (0.378-0.953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5133553"/>
                  </a:ext>
                </a:extLst>
              </a:tr>
              <a:tr h="276625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chest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5537215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,37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1907978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7072703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3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6 (0.387-0.828)*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0268454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2 (0.430-1.019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6108397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0 (0.495-1.017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1255813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5 (0.305-0.805)*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9473781"/>
                  </a:ext>
                </a:extLst>
              </a:tr>
              <a:tr h="276625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abdomen or pelvic contents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6364127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,37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9122431"/>
                  </a:ext>
                </a:extLst>
              </a:tr>
              <a:tr h="362556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0194572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3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5 (0.388-1.244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5249875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9 (0.300-1.158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8615480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2 (0.292-1.082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9746701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1 (0.156-0.743)*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3969637"/>
                  </a:ext>
                </a:extLst>
              </a:tr>
              <a:tr h="276625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extremities or pelvic girdle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578941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,37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0675210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1636884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3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5 (0.510-1.207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3441613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1 (0.537-1.413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kumimoji="1" lang="en-US" altLang="ja-JP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024669"/>
                  </a:ext>
                </a:extLst>
              </a:tr>
              <a:tr h="276625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20</a:t>
                      </a:r>
                      <a:endParaRPr kumimoji="1" lang="en-US" altLang="ja-JP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7 (0.409-1.055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8467564"/>
                  </a:ext>
                </a:extLst>
              </a:tr>
              <a:tr h="276625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8 (0.237-0.809)*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8968027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42C6B8-024E-9DFD-F6A6-7A0D943635B6}"/>
              </a:ext>
            </a:extLst>
          </p:cNvPr>
          <p:cNvSpPr txBox="1"/>
          <p:nvPr/>
        </p:nvSpPr>
        <p:spPr>
          <a:xfrm>
            <a:off x="3524537" y="793370"/>
            <a:ext cx="14294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Favors other than</a:t>
            </a:r>
          </a:p>
          <a:p>
            <a:pPr algn="ctr"/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driver seat</a:t>
            </a:r>
            <a:endParaRPr lang="ja-JP" altLang="en-US" sz="11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31EAC94-10D9-F66A-A660-E4FA26DB9FE8}"/>
              </a:ext>
            </a:extLst>
          </p:cNvPr>
          <p:cNvSpPr txBox="1"/>
          <p:nvPr/>
        </p:nvSpPr>
        <p:spPr>
          <a:xfrm>
            <a:off x="5447114" y="793370"/>
            <a:ext cx="14294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Favors driver seat</a:t>
            </a:r>
            <a:endParaRPr lang="ja-JP" altLang="en-US" sz="11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E3A8E4-DABE-00CE-0F08-9B44F4D29482}"/>
              </a:ext>
            </a:extLst>
          </p:cNvPr>
          <p:cNvSpPr txBox="1"/>
          <p:nvPr/>
        </p:nvSpPr>
        <p:spPr>
          <a:xfrm>
            <a:off x="1067499" y="-169607"/>
            <a:ext cx="115894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6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♂</a:t>
            </a:r>
            <a:endParaRPr kumimoji="1" lang="ja-JP" altLang="en-US" sz="6600" dirty="0">
              <a:solidFill>
                <a:srgbClr val="0070C0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AFF4458-1958-58E5-853B-442FD267A644}"/>
              </a:ext>
            </a:extLst>
          </p:cNvPr>
          <p:cNvSpPr txBox="1"/>
          <p:nvPr/>
        </p:nvSpPr>
        <p:spPr>
          <a:xfrm>
            <a:off x="4311829" y="338554"/>
            <a:ext cx="159285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● </a:t>
            </a:r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Crude analysis</a:t>
            </a:r>
          </a:p>
          <a:p>
            <a:r>
              <a:rPr lang="ja-JP" altLang="en-US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■ </a:t>
            </a:r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Adjusted</a:t>
            </a:r>
            <a:r>
              <a:rPr lang="ja-JP" altLang="en-US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sz="11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analysis</a:t>
            </a:r>
            <a:r>
              <a:rPr lang="en-US" altLang="ja-JP" sz="1100" b="1" baseline="30000" dirty="0" err="1">
                <a:latin typeface="Segoe UI" panose="020B0502040204020203" pitchFamily="34" charset="0"/>
                <a:cs typeface="Segoe UI" panose="020B0502040204020203" pitchFamily="34" charset="0"/>
              </a:rPr>
              <a:t>a</a:t>
            </a:r>
            <a:endParaRPr lang="en-US" altLang="ja-JP" sz="1100" b="1" baseline="300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747F03B-A5F9-C50D-7161-83B3E427942B}"/>
              </a:ext>
            </a:extLst>
          </p:cNvPr>
          <p:cNvSpPr txBox="1"/>
          <p:nvPr/>
        </p:nvSpPr>
        <p:spPr>
          <a:xfrm>
            <a:off x="3107183" y="11351140"/>
            <a:ext cx="6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1708E19-81B2-B263-2794-FABF7848F899}"/>
              </a:ext>
            </a:extLst>
          </p:cNvPr>
          <p:cNvSpPr txBox="1"/>
          <p:nvPr/>
        </p:nvSpPr>
        <p:spPr>
          <a:xfrm>
            <a:off x="4823789" y="11381399"/>
            <a:ext cx="39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A738D1E-C8BE-FA78-535A-BDB87DE7FA40}"/>
              </a:ext>
            </a:extLst>
          </p:cNvPr>
          <p:cNvSpPr txBox="1"/>
          <p:nvPr/>
        </p:nvSpPr>
        <p:spPr>
          <a:xfrm>
            <a:off x="3428999" y="11804449"/>
            <a:ext cx="3192341" cy="3787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R (95% CI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1A70A48-9181-09F3-1B52-5980E865016A}"/>
              </a:ext>
            </a:extLst>
          </p:cNvPr>
          <p:cNvSpPr txBox="1"/>
          <p:nvPr/>
        </p:nvSpPr>
        <p:spPr>
          <a:xfrm>
            <a:off x="-2068" y="15060"/>
            <a:ext cx="7872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96AD7E2-F312-BC22-38F7-6D90EAE18DF0}"/>
              </a:ext>
            </a:extLst>
          </p:cNvPr>
          <p:cNvSpPr txBox="1"/>
          <p:nvPr/>
        </p:nvSpPr>
        <p:spPr>
          <a:xfrm>
            <a:off x="6333584" y="11399869"/>
            <a:ext cx="522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12593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63F4A7-9326-8666-5AAB-FC396CBC21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オブジェクト 14">
            <a:extLst>
              <a:ext uri="{FF2B5EF4-FFF2-40B4-BE49-F238E27FC236}">
                <a16:creationId xmlns:a16="http://schemas.microsoft.com/office/drawing/2014/main" id="{A6A9B90E-F9E4-E2FA-23D5-5357146C83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5313690"/>
              </p:ext>
            </p:extLst>
          </p:nvPr>
        </p:nvGraphicFramePr>
        <p:xfrm>
          <a:off x="2301421" y="1039584"/>
          <a:ext cx="5326295" cy="118891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087735" imgH="2220243" progId="Prism9.Document">
                  <p:embed/>
                </p:oleObj>
              </mc:Choice>
              <mc:Fallback>
                <p:oleObj name="Prism 9" r:id="rId3" imgW="2087735" imgH="2220243" progId="Prism9.Document">
                  <p:embed/>
                  <p:pic>
                    <p:nvPicPr>
                      <p:cNvPr id="15" name="オブジェクト 14">
                        <a:extLst>
                          <a:ext uri="{FF2B5EF4-FFF2-40B4-BE49-F238E27FC236}">
                            <a16:creationId xmlns:a16="http://schemas.microsoft.com/office/drawing/2014/main" id="{A6A9B90E-F9E4-E2FA-23D5-5357146C83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01421" y="1039584"/>
                        <a:ext cx="5326295" cy="118891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94A5201F-C166-66D2-1A48-393FF02D5E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3954001"/>
              </p:ext>
            </p:extLst>
          </p:nvPr>
        </p:nvGraphicFramePr>
        <p:xfrm>
          <a:off x="359988" y="940105"/>
          <a:ext cx="2772410" cy="98475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52855">
                  <a:extLst>
                    <a:ext uri="{9D8B030D-6E8A-4147-A177-3AD203B41FA5}">
                      <a16:colId xmlns:a16="http://schemas.microsoft.com/office/drawing/2014/main" val="2425432630"/>
                    </a:ext>
                  </a:extLst>
                </a:gridCol>
                <a:gridCol w="1519555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267127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</a:t>
                      </a:r>
                      <a:r>
                        <a:rPr kumimoji="1" lang="ja-JP" alt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(95% CI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0908"/>
                  </a:ext>
                </a:extLst>
              </a:tr>
              <a:tr h="267127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vere trauma with ISS of &gt;15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1383435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,72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2811529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4525445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67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260 (0.942-1.685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895 (0.626-1.280)</a:t>
                      </a:r>
                      <a:r>
                        <a:rPr lang="en-US" altLang="ja-JP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47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452 (1.058-1.993)*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347338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31 (0.251-0.738)*</a:t>
                      </a:r>
                      <a:r>
                        <a:rPr lang="en-US" altLang="ja-JP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  <a:tr h="267127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head or neck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8245664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,72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238151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8458124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67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4 (1.025-2.238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7200001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3 (0.806-1.916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1277607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47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2 (1.574-3.426)*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2159094"/>
                  </a:ext>
                </a:extLst>
              </a:tr>
              <a:tr h="336648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2 (0.530-1.782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5133553"/>
                  </a:ext>
                </a:extLst>
              </a:tr>
              <a:tr h="267127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chest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5537215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,72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1907978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7072703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67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4 (0.923-1.649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0268454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2 (0.670-1.353)</a:t>
                      </a:r>
                      <a:r>
                        <a:rPr kumimoji="1" lang="en-US" altLang="ja-JP" sz="1100" b="0" baseline="30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endParaRPr kumimoji="1" lang="ja-JP" altLang="en-US" sz="11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6108397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47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3 (0.848-1.650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1255813"/>
                  </a:ext>
                </a:extLst>
              </a:tr>
              <a:tr h="348331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7 (0.258-0.774)*</a:t>
                      </a:r>
                      <a:r>
                        <a:rPr kumimoji="1" lang="en-US" altLang="ja-JP" sz="1100" b="0" baseline="30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9473781"/>
                  </a:ext>
                </a:extLst>
              </a:tr>
              <a:tr h="267127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abdomen or pelvic contents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6364127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,72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9122431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0194572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67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8 (0.681-1.803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5249875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5 (0.440-1.331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8615480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47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7 (0.547-1.743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9746701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9 (0.178-0.940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3969637"/>
                  </a:ext>
                </a:extLst>
              </a:tr>
              <a:tr h="267127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S extremities or pelvic girdle</a:t>
                      </a:r>
                      <a:r>
                        <a:rPr kumimoji="1"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578941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,72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0675210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1636884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67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0 (0.688-1.666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3441613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0 (0.497-1.351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endParaRPr kumimoji="1" lang="en-US" altLang="ja-JP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024669"/>
                  </a:ext>
                </a:extLst>
              </a:tr>
              <a:tr h="267127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47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67 (1.373-3.110)*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8467564"/>
                  </a:ext>
                </a:extLst>
              </a:tr>
              <a:tr h="267127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 (0.507-1.946)</a:t>
                      </a:r>
                      <a:r>
                        <a:rPr kumimoji="1" lang="en-US" altLang="ja-JP" sz="11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8968027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4A97553-8A5D-6F55-6D95-07FAFF815842}"/>
              </a:ext>
            </a:extLst>
          </p:cNvPr>
          <p:cNvSpPr txBox="1"/>
          <p:nvPr/>
        </p:nvSpPr>
        <p:spPr>
          <a:xfrm>
            <a:off x="3121506" y="927370"/>
            <a:ext cx="142001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Favors other than</a:t>
            </a:r>
          </a:p>
          <a:p>
            <a:pPr algn="ctr"/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driver seat</a:t>
            </a:r>
            <a:endParaRPr lang="ja-JP" altLang="en-US" sz="11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629F64A-A52A-8192-7ECD-FAA6E91B5521}"/>
              </a:ext>
            </a:extLst>
          </p:cNvPr>
          <p:cNvSpPr txBox="1"/>
          <p:nvPr/>
        </p:nvSpPr>
        <p:spPr>
          <a:xfrm>
            <a:off x="4805965" y="927370"/>
            <a:ext cx="13797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Favors driver seat</a:t>
            </a:r>
            <a:endParaRPr lang="ja-JP" altLang="en-US" sz="11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275FA62-BB8A-B446-09F6-903F586056A8}"/>
              </a:ext>
            </a:extLst>
          </p:cNvPr>
          <p:cNvSpPr txBox="1"/>
          <p:nvPr/>
        </p:nvSpPr>
        <p:spPr>
          <a:xfrm>
            <a:off x="4139109" y="338554"/>
            <a:ext cx="159285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● </a:t>
            </a:r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Crude analysis</a:t>
            </a:r>
          </a:p>
          <a:p>
            <a:r>
              <a:rPr lang="ja-JP" altLang="en-US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■ </a:t>
            </a:r>
            <a:r>
              <a:rPr lang="en-US" altLang="ja-JP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Adjusted</a:t>
            </a:r>
            <a:r>
              <a:rPr lang="ja-JP" altLang="en-US" sz="11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sz="11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analysis</a:t>
            </a:r>
            <a:r>
              <a:rPr lang="en-US" altLang="ja-JP" sz="1100" b="1" baseline="30000" dirty="0" err="1">
                <a:latin typeface="Segoe UI" panose="020B0502040204020203" pitchFamily="34" charset="0"/>
                <a:cs typeface="Segoe UI" panose="020B0502040204020203" pitchFamily="34" charset="0"/>
              </a:rPr>
              <a:t>a</a:t>
            </a:r>
            <a:endParaRPr lang="en-US" altLang="ja-JP" sz="1100" b="1" baseline="300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67E03D-EF6C-E15A-7332-3DBDBA69A87F}"/>
              </a:ext>
            </a:extLst>
          </p:cNvPr>
          <p:cNvSpPr txBox="1"/>
          <p:nvPr/>
        </p:nvSpPr>
        <p:spPr>
          <a:xfrm>
            <a:off x="1174957" y="-106680"/>
            <a:ext cx="118021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6600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♀</a:t>
            </a:r>
            <a:endParaRPr kumimoji="1" lang="ja-JP" altLang="en-US" sz="6600" dirty="0">
              <a:solidFill>
                <a:srgbClr val="FF00FF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AAC6AFC-2889-02FF-068D-B9A6CE5187B7}"/>
              </a:ext>
            </a:extLst>
          </p:cNvPr>
          <p:cNvSpPr txBox="1"/>
          <p:nvPr/>
        </p:nvSpPr>
        <p:spPr>
          <a:xfrm>
            <a:off x="3079594" y="11395972"/>
            <a:ext cx="6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B3C92D1-00D6-E17F-FC9B-AAAD2C54ED1E}"/>
              </a:ext>
            </a:extLst>
          </p:cNvPr>
          <p:cNvSpPr txBox="1"/>
          <p:nvPr/>
        </p:nvSpPr>
        <p:spPr>
          <a:xfrm>
            <a:off x="4756185" y="11403095"/>
            <a:ext cx="39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C010111-196B-4AEA-A145-F1BEE597F77B}"/>
              </a:ext>
            </a:extLst>
          </p:cNvPr>
          <p:cNvSpPr txBox="1"/>
          <p:nvPr/>
        </p:nvSpPr>
        <p:spPr>
          <a:xfrm>
            <a:off x="3429000" y="11812138"/>
            <a:ext cx="3122271" cy="3787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R (95% CI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D734124-D9A4-BC7C-5CAF-BD03029215D3}"/>
              </a:ext>
            </a:extLst>
          </p:cNvPr>
          <p:cNvSpPr txBox="1"/>
          <p:nvPr/>
        </p:nvSpPr>
        <p:spPr>
          <a:xfrm>
            <a:off x="6237762" y="11398783"/>
            <a:ext cx="55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5497F71-C375-D41A-E858-F2396305E071}"/>
              </a:ext>
            </a:extLst>
          </p:cNvPr>
          <p:cNvSpPr txBox="1"/>
          <p:nvPr/>
        </p:nvSpPr>
        <p:spPr>
          <a:xfrm>
            <a:off x="-2068" y="15060"/>
            <a:ext cx="7872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4779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104</TotalTime>
  <Words>1238</Words>
  <Application>Microsoft Office PowerPoint</Application>
  <PresentationFormat>ワイド画面</PresentationFormat>
  <Paragraphs>162</Paragraphs>
  <Slides>2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Segoe UI</vt:lpstr>
      <vt:lpstr>Times New Roman</vt:lpstr>
      <vt:lpstr>Office テーマ</vt:lpstr>
      <vt:lpstr>Prism 9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佑 鵜澤</dc:creator>
  <cp:lastModifiedBy>雄康 大野</cp:lastModifiedBy>
  <cp:revision>15</cp:revision>
  <dcterms:created xsi:type="dcterms:W3CDTF">2024-11-07T06:41:14Z</dcterms:created>
  <dcterms:modified xsi:type="dcterms:W3CDTF">2025-05-02T08:58:58Z</dcterms:modified>
</cp:coreProperties>
</file>